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90" autoAdjust="0"/>
  </p:normalViewPr>
  <p:slideViewPr>
    <p:cSldViewPr snapToGrid="0">
      <p:cViewPr varScale="1">
        <p:scale>
          <a:sx n="81" d="100"/>
          <a:sy n="81" d="100"/>
        </p:scale>
        <p:origin x="90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A7A58D-1874-4A50-BD83-5F8978ED1CD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A3C116-7A0A-4DB2-9372-7FA580A8FB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78649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3C116-7A0A-4DB2-9372-7FA580A8FB7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051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54B412F-3913-E5E3-99A6-CDF8B81ACB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33FC5CF7-F8AF-DF41-B46D-29E25E75AF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D78CDC7F-FC48-8DFC-0548-C6A6C3108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32FEEC6-123D-7F5E-6CE1-CC006D0A2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A68B7434-F992-37EF-C613-A578340F9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425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E48A3E97-B71E-749B-C7E1-AC0FFC4DE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0207C6DB-1C8A-3270-F296-BFC24258E9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FCCE81E-1B32-21CF-3B3A-E6B4688F1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A5A82480-EEE5-065E-FFF2-94C69890B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1EB67A41-DDC4-1FD8-2174-CF1C5A3BA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6046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CA31AC74-C3E2-6CF1-D65C-BC7D4D5108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EFD57CE2-3B9B-0A6C-8257-CA4B71C447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1EEC0FD-8FFF-2508-B94A-D62AD74CD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469E62A4-A5F5-1CFE-6BDA-B2ABE379D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AB9EBEB0-BBDF-EDAD-AC3C-50BFC2916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5028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7EF233F5-63F6-4F7A-7A1F-4D911C72AC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7FEBA706-3D5C-6D79-0464-2F0B6DDC4B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19C6D523-2D9F-EFE3-0633-39FD949D0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06DB9845-38D3-8AE7-92EF-EB7FF8104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DA94D88-4B2C-935E-51C7-78DC4D5D2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933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88959EC-6731-C917-7BC9-91AEEF6654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C17992E8-F153-5EBB-7722-31A1F98955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BF323A32-1FF4-1A3F-799D-C76F723E3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87084A6-46FC-E643-0905-F6C33D84D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7B372CCA-F696-DF6A-4950-7AC082867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1768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7A562090-F201-A205-560C-834F0DD33B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B9531FC8-4333-26D8-AFBA-2ECF789DC7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0856DCE8-0BDF-7957-594D-FA7D4D57A1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14236E86-4139-87A1-EAA5-31A9C3A0DC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120640D6-939A-4B60-0C92-5033222CA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142CC27B-7215-815C-F13E-32B52D53C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006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2C640C7-45EE-0145-BFA9-F2239A16B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52DEB4DC-A860-95EA-7E6F-E5209116D4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3059F8C5-D444-EE20-39A5-3A5DC98C0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81718600-76AD-318F-B06B-91ED2B1D45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0042408A-2FF4-32F5-A20C-0AA91C91DB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860A3B7C-E469-D00A-9BD3-2E230D0E3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A1A8C427-E3A3-AE25-3F28-B593051E3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5CE79735-A3F8-175E-6C70-E1386BEAD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37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A235DA1-59CE-70CB-806C-F2CB1DD174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51E0D54C-6265-CEBB-6E19-F9960CE69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91184607-2585-224A-BCC4-8FE85589D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F28FD95D-5B5A-32A1-6738-020C0A148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7222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59858220-3809-09AD-6A3E-570F45169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CDD2BB2-FD71-87C2-5129-FE1E1D595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BBCF08B3-0854-5DCD-85B2-8043B6E23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9726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253ECB36-3AEE-2BD6-2423-6A3D4A466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0638735-CFC6-7249-77EA-A194820290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17FA480A-F709-8F6D-E97D-C0ADE9A324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4877AF4C-B7CF-9600-EA07-29C3637FF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7C60DCAA-3573-CC32-C061-BCBDBA110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F758FED9-F6D0-4196-EB23-F75550C77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89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9E49C8A-A18E-6A06-BBA1-900B526FD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40C0FE7A-7364-ED64-972F-D8D98F80A8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41B726CB-4391-D140-C85B-328C0C6417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94344B39-49C0-C59F-AACA-EEC5D5037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9FA29D8E-5C04-34FC-B18E-856122666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FA1370B3-42DA-5450-7C04-A2C7E1436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086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D90A3EEB-3AE5-EAF4-95A2-85A9C7A12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6D629A12-6105-7CA5-331C-7D676C15F1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9DFDDBC-5D34-A075-A607-47A1D323F4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5AF0F-8E8C-46BF-84DC-1D460E8BAAB2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D7A3B77B-DF0E-DD32-D6EB-2AC4130D43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FE72C052-9F89-4592-6F17-9BA80D2D3A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7AEAA-F8BC-437A-8624-184F0A403D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7682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="" xmlns:a16="http://schemas.microsoft.com/office/drawing/2014/main" id="{590F6807-A81B-8896-5764-B4DAC082FA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73309" y="418479"/>
            <a:ext cx="2857834" cy="2834151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="" xmlns:a16="http://schemas.microsoft.com/office/drawing/2014/main" id="{715D377A-34CC-1766-EECE-AD959F2BF87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2433" y="438717"/>
            <a:ext cx="2809851" cy="2786565"/>
          </a:xfrm>
          <a:prstGeom prst="rect">
            <a:avLst/>
          </a:prstGeom>
        </p:spPr>
      </p:pic>
      <p:grpSp>
        <p:nvGrpSpPr>
          <p:cNvPr id="2" name="Group 4">
            <a:extLst>
              <a:ext uri="{FF2B5EF4-FFF2-40B4-BE49-F238E27FC236}">
                <a16:creationId xmlns="" xmlns:a16="http://schemas.microsoft.com/office/drawing/2014/main" id="{2A8980B4-DD1B-9770-47FD-ECF8D40DAABC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667860" y="401479"/>
            <a:ext cx="2837561" cy="2814677"/>
            <a:chOff x="3543" y="984"/>
            <a:chExt cx="1860" cy="1845"/>
          </a:xfrm>
        </p:grpSpPr>
        <p:sp>
          <p:nvSpPr>
            <p:cNvPr id="3" name="AutoShape 3">
              <a:extLst>
                <a:ext uri="{FF2B5EF4-FFF2-40B4-BE49-F238E27FC236}">
                  <a16:creationId xmlns="" xmlns:a16="http://schemas.microsoft.com/office/drawing/2014/main" id="{7C7B5CE3-AA78-969C-F322-4B54F186A35D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3543" y="984"/>
              <a:ext cx="1860" cy="18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" name="Rectangle 5">
              <a:extLst>
                <a:ext uri="{FF2B5EF4-FFF2-40B4-BE49-F238E27FC236}">
                  <a16:creationId xmlns="" xmlns:a16="http://schemas.microsoft.com/office/drawing/2014/main" id="{5890154E-B356-3795-E580-0A605727E8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0" y="1148"/>
              <a:ext cx="1315" cy="131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" name="Rectangle 6">
              <a:extLst>
                <a:ext uri="{FF2B5EF4-FFF2-40B4-BE49-F238E27FC236}">
                  <a16:creationId xmlns="" xmlns:a16="http://schemas.microsoft.com/office/drawing/2014/main" id="{6CB34583-E601-1A41-8969-A6400BF1E3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5" y="1174"/>
              <a:ext cx="108" cy="12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" name="Rectangle 7">
              <a:extLst>
                <a:ext uri="{FF2B5EF4-FFF2-40B4-BE49-F238E27FC236}">
                  <a16:creationId xmlns="" xmlns:a16="http://schemas.microsoft.com/office/drawing/2014/main" id="{69CBBDCC-6FC5-ECF8-E2BD-284584546F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5" y="1199"/>
              <a:ext cx="149" cy="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Freeform 8">
              <a:extLst>
                <a:ext uri="{FF2B5EF4-FFF2-40B4-BE49-F238E27FC236}">
                  <a16:creationId xmlns="" xmlns:a16="http://schemas.microsoft.com/office/drawing/2014/main" id="{CE5283A8-F25B-E1AD-765E-712D26748272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1" y="1786"/>
              <a:ext cx="699" cy="10"/>
            </a:xfrm>
            <a:custGeom>
              <a:avLst/>
              <a:gdLst>
                <a:gd name="T0" fmla="*/ 6 w 699"/>
                <a:gd name="T1" fmla="*/ 0 h 10"/>
                <a:gd name="T2" fmla="*/ 0 w 699"/>
                <a:gd name="T3" fmla="*/ 0 h 10"/>
                <a:gd name="T4" fmla="*/ 0 w 699"/>
                <a:gd name="T5" fmla="*/ 5 h 10"/>
                <a:gd name="T6" fmla="*/ 0 w 699"/>
                <a:gd name="T7" fmla="*/ 10 h 10"/>
                <a:gd name="T8" fmla="*/ 6 w 699"/>
                <a:gd name="T9" fmla="*/ 10 h 10"/>
                <a:gd name="T10" fmla="*/ 694 w 699"/>
                <a:gd name="T11" fmla="*/ 10 h 10"/>
                <a:gd name="T12" fmla="*/ 699 w 699"/>
                <a:gd name="T13" fmla="*/ 10 h 10"/>
                <a:gd name="T14" fmla="*/ 699 w 699"/>
                <a:gd name="T15" fmla="*/ 5 h 10"/>
                <a:gd name="T16" fmla="*/ 699 w 699"/>
                <a:gd name="T17" fmla="*/ 0 h 10"/>
                <a:gd name="T18" fmla="*/ 694 w 699"/>
                <a:gd name="T19" fmla="*/ 0 h 10"/>
                <a:gd name="T20" fmla="*/ 6 w 699"/>
                <a:gd name="T21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99" h="10">
                  <a:moveTo>
                    <a:pt x="6" y="0"/>
                  </a:moveTo>
                  <a:lnTo>
                    <a:pt x="0" y="0"/>
                  </a:lnTo>
                  <a:lnTo>
                    <a:pt x="0" y="5"/>
                  </a:lnTo>
                  <a:lnTo>
                    <a:pt x="0" y="10"/>
                  </a:lnTo>
                  <a:lnTo>
                    <a:pt x="6" y="10"/>
                  </a:lnTo>
                  <a:lnTo>
                    <a:pt x="694" y="10"/>
                  </a:lnTo>
                  <a:lnTo>
                    <a:pt x="699" y="10"/>
                  </a:lnTo>
                  <a:lnTo>
                    <a:pt x="699" y="5"/>
                  </a:lnTo>
                  <a:lnTo>
                    <a:pt x="699" y="0"/>
                  </a:lnTo>
                  <a:lnTo>
                    <a:pt x="694" y="0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Freeform 9">
              <a:extLst>
                <a:ext uri="{FF2B5EF4-FFF2-40B4-BE49-F238E27FC236}">
                  <a16:creationId xmlns="" xmlns:a16="http://schemas.microsoft.com/office/drawing/2014/main" id="{7F1FC75A-1808-6F6A-8E12-7FB6192D790E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1" y="1148"/>
              <a:ext cx="11" cy="648"/>
            </a:xfrm>
            <a:custGeom>
              <a:avLst/>
              <a:gdLst>
                <a:gd name="T0" fmla="*/ 0 w 11"/>
                <a:gd name="T1" fmla="*/ 0 h 648"/>
                <a:gd name="T2" fmla="*/ 0 w 11"/>
                <a:gd name="T3" fmla="*/ 643 h 648"/>
                <a:gd name="T4" fmla="*/ 0 w 11"/>
                <a:gd name="T5" fmla="*/ 648 h 648"/>
                <a:gd name="T6" fmla="*/ 6 w 11"/>
                <a:gd name="T7" fmla="*/ 648 h 648"/>
                <a:gd name="T8" fmla="*/ 11 w 11"/>
                <a:gd name="T9" fmla="*/ 648 h 648"/>
                <a:gd name="T10" fmla="*/ 11 w 11"/>
                <a:gd name="T11" fmla="*/ 643 h 648"/>
                <a:gd name="T12" fmla="*/ 11 w 11"/>
                <a:gd name="T13" fmla="*/ 0 h 648"/>
                <a:gd name="T14" fmla="*/ 0 w 11"/>
                <a:gd name="T15" fmla="*/ 0 h 6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" h="648">
                  <a:moveTo>
                    <a:pt x="0" y="0"/>
                  </a:moveTo>
                  <a:lnTo>
                    <a:pt x="0" y="643"/>
                  </a:lnTo>
                  <a:lnTo>
                    <a:pt x="0" y="648"/>
                  </a:lnTo>
                  <a:lnTo>
                    <a:pt x="6" y="648"/>
                  </a:lnTo>
                  <a:lnTo>
                    <a:pt x="11" y="648"/>
                  </a:lnTo>
                  <a:lnTo>
                    <a:pt x="11" y="643"/>
                  </a:lnTo>
                  <a:lnTo>
                    <a:pt x="1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Rectangle 10">
              <a:extLst>
                <a:ext uri="{FF2B5EF4-FFF2-40B4-BE49-F238E27FC236}">
                  <a16:creationId xmlns="" xmlns:a16="http://schemas.microsoft.com/office/drawing/2014/main" id="{8A7828D3-4FA7-DC27-B71D-7E42079038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0" y="1174"/>
              <a:ext cx="108" cy="12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11">
              <a:extLst>
                <a:ext uri="{FF2B5EF4-FFF2-40B4-BE49-F238E27FC236}">
                  <a16:creationId xmlns="" xmlns:a16="http://schemas.microsoft.com/office/drawing/2014/main" id="{B54469DD-785B-E600-4513-29663837A8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0" y="1199"/>
              <a:ext cx="149" cy="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Freeform 12">
              <a:extLst>
                <a:ext uri="{FF2B5EF4-FFF2-40B4-BE49-F238E27FC236}">
                  <a16:creationId xmlns="" xmlns:a16="http://schemas.microsoft.com/office/drawing/2014/main" id="{F019326F-9C20-6839-1606-6195D2377DA2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1" y="1786"/>
              <a:ext cx="699" cy="10"/>
            </a:xfrm>
            <a:custGeom>
              <a:avLst/>
              <a:gdLst>
                <a:gd name="T0" fmla="*/ 6 w 699"/>
                <a:gd name="T1" fmla="*/ 0 h 10"/>
                <a:gd name="T2" fmla="*/ 0 w 699"/>
                <a:gd name="T3" fmla="*/ 0 h 10"/>
                <a:gd name="T4" fmla="*/ 0 w 699"/>
                <a:gd name="T5" fmla="*/ 5 h 10"/>
                <a:gd name="T6" fmla="*/ 0 w 699"/>
                <a:gd name="T7" fmla="*/ 10 h 10"/>
                <a:gd name="T8" fmla="*/ 6 w 699"/>
                <a:gd name="T9" fmla="*/ 10 h 10"/>
                <a:gd name="T10" fmla="*/ 694 w 699"/>
                <a:gd name="T11" fmla="*/ 10 h 10"/>
                <a:gd name="T12" fmla="*/ 699 w 699"/>
                <a:gd name="T13" fmla="*/ 10 h 10"/>
                <a:gd name="T14" fmla="*/ 699 w 699"/>
                <a:gd name="T15" fmla="*/ 5 h 10"/>
                <a:gd name="T16" fmla="*/ 699 w 699"/>
                <a:gd name="T17" fmla="*/ 0 h 10"/>
                <a:gd name="T18" fmla="*/ 694 w 699"/>
                <a:gd name="T19" fmla="*/ 0 h 10"/>
                <a:gd name="T20" fmla="*/ 6 w 699"/>
                <a:gd name="T21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99" h="10">
                  <a:moveTo>
                    <a:pt x="6" y="0"/>
                  </a:moveTo>
                  <a:lnTo>
                    <a:pt x="0" y="0"/>
                  </a:lnTo>
                  <a:lnTo>
                    <a:pt x="0" y="5"/>
                  </a:lnTo>
                  <a:lnTo>
                    <a:pt x="0" y="10"/>
                  </a:lnTo>
                  <a:lnTo>
                    <a:pt x="6" y="10"/>
                  </a:lnTo>
                  <a:lnTo>
                    <a:pt x="694" y="10"/>
                  </a:lnTo>
                  <a:lnTo>
                    <a:pt x="699" y="10"/>
                  </a:lnTo>
                  <a:lnTo>
                    <a:pt x="699" y="5"/>
                  </a:lnTo>
                  <a:lnTo>
                    <a:pt x="699" y="0"/>
                  </a:lnTo>
                  <a:lnTo>
                    <a:pt x="694" y="0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Freeform 13">
              <a:extLst>
                <a:ext uri="{FF2B5EF4-FFF2-40B4-BE49-F238E27FC236}">
                  <a16:creationId xmlns="" xmlns:a16="http://schemas.microsoft.com/office/drawing/2014/main" id="{4C0F6870-5796-A991-0FE4-007808C4596E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1" y="1786"/>
              <a:ext cx="11" cy="683"/>
            </a:xfrm>
            <a:custGeom>
              <a:avLst/>
              <a:gdLst>
                <a:gd name="T0" fmla="*/ 6 w 11"/>
                <a:gd name="T1" fmla="*/ 0 h 683"/>
                <a:gd name="T2" fmla="*/ 0 w 11"/>
                <a:gd name="T3" fmla="*/ 0 h 683"/>
                <a:gd name="T4" fmla="*/ 0 w 11"/>
                <a:gd name="T5" fmla="*/ 5 h 683"/>
                <a:gd name="T6" fmla="*/ 0 w 11"/>
                <a:gd name="T7" fmla="*/ 678 h 683"/>
                <a:gd name="T8" fmla="*/ 0 w 11"/>
                <a:gd name="T9" fmla="*/ 683 h 683"/>
                <a:gd name="T10" fmla="*/ 6 w 11"/>
                <a:gd name="T11" fmla="*/ 683 h 683"/>
                <a:gd name="T12" fmla="*/ 11 w 11"/>
                <a:gd name="T13" fmla="*/ 683 h 683"/>
                <a:gd name="T14" fmla="*/ 11 w 11"/>
                <a:gd name="T15" fmla="*/ 678 h 683"/>
                <a:gd name="T16" fmla="*/ 11 w 11"/>
                <a:gd name="T17" fmla="*/ 5 h 683"/>
                <a:gd name="T18" fmla="*/ 11 w 11"/>
                <a:gd name="T19" fmla="*/ 0 h 683"/>
                <a:gd name="T20" fmla="*/ 6 w 11"/>
                <a:gd name="T21" fmla="*/ 0 h 6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1" h="683">
                  <a:moveTo>
                    <a:pt x="6" y="0"/>
                  </a:moveTo>
                  <a:lnTo>
                    <a:pt x="0" y="0"/>
                  </a:lnTo>
                  <a:lnTo>
                    <a:pt x="0" y="5"/>
                  </a:lnTo>
                  <a:lnTo>
                    <a:pt x="0" y="678"/>
                  </a:lnTo>
                  <a:lnTo>
                    <a:pt x="0" y="683"/>
                  </a:lnTo>
                  <a:lnTo>
                    <a:pt x="6" y="683"/>
                  </a:lnTo>
                  <a:lnTo>
                    <a:pt x="11" y="683"/>
                  </a:lnTo>
                  <a:lnTo>
                    <a:pt x="11" y="678"/>
                  </a:lnTo>
                  <a:lnTo>
                    <a:pt x="11" y="5"/>
                  </a:lnTo>
                  <a:lnTo>
                    <a:pt x="11" y="0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Rectangle 14">
              <a:extLst>
                <a:ext uri="{FF2B5EF4-FFF2-40B4-BE49-F238E27FC236}">
                  <a16:creationId xmlns="" xmlns:a16="http://schemas.microsoft.com/office/drawing/2014/main" id="{7E3D1C43-6BE6-4F77-DEF7-CE0B46ED76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0" y="2315"/>
              <a:ext cx="108" cy="12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Rectangle 15">
              <a:extLst>
                <a:ext uri="{FF2B5EF4-FFF2-40B4-BE49-F238E27FC236}">
                  <a16:creationId xmlns="" xmlns:a16="http://schemas.microsoft.com/office/drawing/2014/main" id="{088A767F-01C5-F24A-E0DB-0708043F97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0" y="2340"/>
              <a:ext cx="149" cy="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9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Freeform 16">
              <a:extLst>
                <a:ext uri="{FF2B5EF4-FFF2-40B4-BE49-F238E27FC236}">
                  <a16:creationId xmlns="" xmlns:a16="http://schemas.microsoft.com/office/drawing/2014/main" id="{FFDB4B4A-C0C6-DA20-F79F-B77ACED265BC}"/>
                </a:ext>
              </a:extLst>
            </p:cNvPr>
            <p:cNvSpPr>
              <a:spLocks/>
            </p:cNvSpPr>
            <p:nvPr/>
          </p:nvSpPr>
          <p:spPr bwMode="auto">
            <a:xfrm>
              <a:off x="3980" y="1786"/>
              <a:ext cx="632" cy="10"/>
            </a:xfrm>
            <a:custGeom>
              <a:avLst/>
              <a:gdLst>
                <a:gd name="T0" fmla="*/ 0 w 632"/>
                <a:gd name="T1" fmla="*/ 0 h 10"/>
                <a:gd name="T2" fmla="*/ 0 w 632"/>
                <a:gd name="T3" fmla="*/ 10 h 10"/>
                <a:gd name="T4" fmla="*/ 627 w 632"/>
                <a:gd name="T5" fmla="*/ 10 h 10"/>
                <a:gd name="T6" fmla="*/ 632 w 632"/>
                <a:gd name="T7" fmla="*/ 10 h 10"/>
                <a:gd name="T8" fmla="*/ 632 w 632"/>
                <a:gd name="T9" fmla="*/ 5 h 10"/>
                <a:gd name="T10" fmla="*/ 632 w 632"/>
                <a:gd name="T11" fmla="*/ 0 h 10"/>
                <a:gd name="T12" fmla="*/ 627 w 632"/>
                <a:gd name="T13" fmla="*/ 0 h 10"/>
                <a:gd name="T14" fmla="*/ 0 w 632"/>
                <a:gd name="T15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32" h="10">
                  <a:moveTo>
                    <a:pt x="0" y="0"/>
                  </a:moveTo>
                  <a:lnTo>
                    <a:pt x="0" y="10"/>
                  </a:lnTo>
                  <a:lnTo>
                    <a:pt x="627" y="10"/>
                  </a:lnTo>
                  <a:lnTo>
                    <a:pt x="632" y="10"/>
                  </a:lnTo>
                  <a:lnTo>
                    <a:pt x="632" y="5"/>
                  </a:lnTo>
                  <a:lnTo>
                    <a:pt x="632" y="0"/>
                  </a:lnTo>
                  <a:lnTo>
                    <a:pt x="627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Freeform 17">
              <a:extLst>
                <a:ext uri="{FF2B5EF4-FFF2-40B4-BE49-F238E27FC236}">
                  <a16:creationId xmlns="" xmlns:a16="http://schemas.microsoft.com/office/drawing/2014/main" id="{561B4E83-609D-2C44-D4F8-674A2CE87BA9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1" y="1786"/>
              <a:ext cx="11" cy="683"/>
            </a:xfrm>
            <a:custGeom>
              <a:avLst/>
              <a:gdLst>
                <a:gd name="T0" fmla="*/ 6 w 11"/>
                <a:gd name="T1" fmla="*/ 0 h 683"/>
                <a:gd name="T2" fmla="*/ 0 w 11"/>
                <a:gd name="T3" fmla="*/ 0 h 683"/>
                <a:gd name="T4" fmla="*/ 0 w 11"/>
                <a:gd name="T5" fmla="*/ 5 h 683"/>
                <a:gd name="T6" fmla="*/ 0 w 11"/>
                <a:gd name="T7" fmla="*/ 678 h 683"/>
                <a:gd name="T8" fmla="*/ 0 w 11"/>
                <a:gd name="T9" fmla="*/ 683 h 683"/>
                <a:gd name="T10" fmla="*/ 6 w 11"/>
                <a:gd name="T11" fmla="*/ 683 h 683"/>
                <a:gd name="T12" fmla="*/ 11 w 11"/>
                <a:gd name="T13" fmla="*/ 683 h 683"/>
                <a:gd name="T14" fmla="*/ 11 w 11"/>
                <a:gd name="T15" fmla="*/ 678 h 683"/>
                <a:gd name="T16" fmla="*/ 11 w 11"/>
                <a:gd name="T17" fmla="*/ 5 h 683"/>
                <a:gd name="T18" fmla="*/ 11 w 11"/>
                <a:gd name="T19" fmla="*/ 0 h 683"/>
                <a:gd name="T20" fmla="*/ 6 w 11"/>
                <a:gd name="T21" fmla="*/ 0 h 6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1" h="683">
                  <a:moveTo>
                    <a:pt x="6" y="0"/>
                  </a:moveTo>
                  <a:lnTo>
                    <a:pt x="0" y="0"/>
                  </a:lnTo>
                  <a:lnTo>
                    <a:pt x="0" y="5"/>
                  </a:lnTo>
                  <a:lnTo>
                    <a:pt x="0" y="678"/>
                  </a:lnTo>
                  <a:lnTo>
                    <a:pt x="0" y="683"/>
                  </a:lnTo>
                  <a:lnTo>
                    <a:pt x="6" y="683"/>
                  </a:lnTo>
                  <a:lnTo>
                    <a:pt x="11" y="683"/>
                  </a:lnTo>
                  <a:lnTo>
                    <a:pt x="11" y="678"/>
                  </a:lnTo>
                  <a:lnTo>
                    <a:pt x="11" y="5"/>
                  </a:lnTo>
                  <a:lnTo>
                    <a:pt x="11" y="0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Rectangle 18">
              <a:extLst>
                <a:ext uri="{FF2B5EF4-FFF2-40B4-BE49-F238E27FC236}">
                  <a16:creationId xmlns="" xmlns:a16="http://schemas.microsoft.com/office/drawing/2014/main" id="{5EADC363-F145-060E-7293-365D598404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5" y="2315"/>
              <a:ext cx="108" cy="12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Rectangle 19">
              <a:extLst>
                <a:ext uri="{FF2B5EF4-FFF2-40B4-BE49-F238E27FC236}">
                  <a16:creationId xmlns="" xmlns:a16="http://schemas.microsoft.com/office/drawing/2014/main" id="{8AD477F6-BFCD-6708-3263-A9F8B5BC4D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5" y="2340"/>
              <a:ext cx="149" cy="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9.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pic>
          <p:nvPicPr>
            <p:cNvPr id="1044" name="Picture 20">
              <a:extLst>
                <a:ext uri="{FF2B5EF4-FFF2-40B4-BE49-F238E27FC236}">
                  <a16:creationId xmlns="" xmlns:a16="http://schemas.microsoft.com/office/drawing/2014/main" id="{0D37F4A1-5004-0F1F-ABB3-F85A90034A8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80" y="1148"/>
              <a:ext cx="1315" cy="13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5" name="Picture 21">
              <a:extLst>
                <a:ext uri="{FF2B5EF4-FFF2-40B4-BE49-F238E27FC236}">
                  <a16:creationId xmlns="" xmlns:a16="http://schemas.microsoft.com/office/drawing/2014/main" id="{17B5DE5A-7E06-1C93-CB5C-A1507F632DA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80" y="1148"/>
              <a:ext cx="1315" cy="13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Freeform 22">
              <a:extLst>
                <a:ext uri="{FF2B5EF4-FFF2-40B4-BE49-F238E27FC236}">
                  <a16:creationId xmlns="" xmlns:a16="http://schemas.microsoft.com/office/drawing/2014/main" id="{75B06456-D902-4E62-277D-32F64193E5E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80" y="1148"/>
              <a:ext cx="1315" cy="1316"/>
            </a:xfrm>
            <a:custGeom>
              <a:avLst/>
              <a:gdLst>
                <a:gd name="T0" fmla="*/ 0 w 1315"/>
                <a:gd name="T1" fmla="*/ 0 h 1316"/>
                <a:gd name="T2" fmla="*/ 1315 w 1315"/>
                <a:gd name="T3" fmla="*/ 0 h 1316"/>
                <a:gd name="T4" fmla="*/ 1315 w 1315"/>
                <a:gd name="T5" fmla="*/ 1316 h 1316"/>
                <a:gd name="T6" fmla="*/ 0 w 1315"/>
                <a:gd name="T7" fmla="*/ 1316 h 1316"/>
                <a:gd name="T8" fmla="*/ 0 w 1315"/>
                <a:gd name="T9" fmla="*/ 0 h 1316"/>
                <a:gd name="T10" fmla="*/ 0 w 1315"/>
                <a:gd name="T11" fmla="*/ 0 h 1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15" h="1316">
                  <a:moveTo>
                    <a:pt x="0" y="0"/>
                  </a:moveTo>
                  <a:lnTo>
                    <a:pt x="1315" y="0"/>
                  </a:lnTo>
                  <a:lnTo>
                    <a:pt x="1315" y="1316"/>
                  </a:lnTo>
                  <a:lnTo>
                    <a:pt x="0" y="1316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="" xmlns:a16="http://schemas.microsoft.com/office/drawing/2014/main" id="{369BF35D-1CEE-6636-EC38-14D661DD30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0" y="2464"/>
              <a:ext cx="10" cy="3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="" xmlns:a16="http://schemas.microsoft.com/office/drawing/2014/main" id="{6C5082F0-FC3D-6CBC-1DD1-98FAC78801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5" y="2531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="" xmlns:a16="http://schemas.microsoft.com/office/drawing/2014/main" id="{B2278EC5-F5CB-D157-AE4B-404140A5AA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7" y="2500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="" xmlns:a16="http://schemas.microsoft.com/office/drawing/2014/main" id="{BDA01E58-1C61-1C79-76F8-EF6AC74BDB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7" y="2464"/>
              <a:ext cx="6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="" xmlns:a16="http://schemas.microsoft.com/office/drawing/2014/main" id="{A2FF7744-0CA4-6E6E-FD67-1056CC8D67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4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="" xmlns:a16="http://schemas.microsoft.com/office/drawing/2014/main" id="{00399B39-0551-9195-1F2E-1BC3FEC65D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5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="" xmlns:a16="http://schemas.microsoft.com/office/drawing/2014/main" id="{74590A7C-89B9-3664-BB23-2C4C2579B2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6" y="2464"/>
              <a:ext cx="10" cy="2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="" xmlns:a16="http://schemas.microsoft.com/office/drawing/2014/main" id="{09C5F117-DE91-A211-EC77-5598EF8901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7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="" xmlns:a16="http://schemas.microsoft.com/office/drawing/2014/main" id="{8D6DFCC3-D2C7-B446-76AA-5FA93113CF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7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="" xmlns:a16="http://schemas.microsoft.com/office/drawing/2014/main" id="{B4B927EB-C320-6607-36BD-ED84062A5F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8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="" xmlns:a16="http://schemas.microsoft.com/office/drawing/2014/main" id="{1B98F710-E315-A542-C649-3B29277E7F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3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="" xmlns:a16="http://schemas.microsoft.com/office/drawing/2014/main" id="{06662152-F547-B9D5-DB00-C5C152C73E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3" y="2464"/>
              <a:ext cx="11" cy="3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="" xmlns:a16="http://schemas.microsoft.com/office/drawing/2014/main" id="{EA3C0DA8-5E52-92D9-DC9C-756EE79E5E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9" y="2531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="" xmlns:a16="http://schemas.microsoft.com/office/drawing/2014/main" id="{1BD0258C-1400-7A27-CA78-8ED74949FC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0" y="2500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="" xmlns:a16="http://schemas.microsoft.com/office/drawing/2014/main" id="{5052EFCC-E212-0246-CDD3-243A05F7E9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6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="" xmlns:a16="http://schemas.microsoft.com/office/drawing/2014/main" id="{0A67EF63-6879-E7A9-226F-DC3E25C991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3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="" xmlns:a16="http://schemas.microsoft.com/office/drawing/2014/main" id="{D2121288-337E-F478-A5E4-FAA28E0180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4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="" xmlns:a16="http://schemas.microsoft.com/office/drawing/2014/main" id="{13F50231-7924-8D75-4423-988784F979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0" y="2464"/>
              <a:ext cx="10" cy="2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="" xmlns:a16="http://schemas.microsoft.com/office/drawing/2014/main" id="{782D76A6-8EEB-DAEE-1B08-06B971D0D5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0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="" xmlns:a16="http://schemas.microsoft.com/office/drawing/2014/main" id="{DF8B1F9B-ED9F-62C1-6709-ED1A69D7D4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6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="" xmlns:a16="http://schemas.microsoft.com/office/drawing/2014/main" id="{D4E22BAE-BA58-9936-4917-53BC3199D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1" y="2464"/>
              <a:ext cx="6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="" xmlns:a16="http://schemas.microsoft.com/office/drawing/2014/main" id="{CCACBD22-2B63-9F2B-BE9B-1DDD7ACA6D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2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="" xmlns:a16="http://schemas.microsoft.com/office/drawing/2014/main" id="{AEEF5588-0842-78E7-BFA5-66DBACB625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2" y="2464"/>
              <a:ext cx="11" cy="3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="" xmlns:a16="http://schemas.microsoft.com/office/drawing/2014/main" id="{753071DD-C4E0-76A2-198D-F964578C56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7" y="2531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="" xmlns:a16="http://schemas.microsoft.com/office/drawing/2014/main" id="{46A701AD-4346-5A7D-0E3D-E30016FEC9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9" y="2500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="" xmlns:a16="http://schemas.microsoft.com/office/drawing/2014/main" id="{E65C1D59-B8F7-36F2-46BE-434F45BB09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5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="" xmlns:a16="http://schemas.microsoft.com/office/drawing/2014/main" id="{D831A076-39B7-CB51-2621-D0FF58AFC5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2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="" xmlns:a16="http://schemas.microsoft.com/office/drawing/2014/main" id="{A4AABE54-C606-AFEE-8C5E-047F725285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3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="" xmlns:a16="http://schemas.microsoft.com/office/drawing/2014/main" id="{6CF9E629-187C-3C4B-A112-2BC89F99B2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8" y="2464"/>
              <a:ext cx="11" cy="2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="" xmlns:a16="http://schemas.microsoft.com/office/drawing/2014/main" id="{CDCE9385-ABDC-366D-2A6D-560519128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9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="" xmlns:a16="http://schemas.microsoft.com/office/drawing/2014/main" id="{D73A128B-3358-D9FE-8A47-E9C61EC74E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0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="" xmlns:a16="http://schemas.microsoft.com/office/drawing/2014/main" id="{0A15D15B-0C77-0282-852E-A0F01E2F30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0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="" xmlns:a16="http://schemas.microsoft.com/office/drawing/2014/main" id="{B141A9C9-F7DF-0844-BCFA-815337B364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46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Rectangle 56">
              <a:extLst>
                <a:ext uri="{FF2B5EF4-FFF2-40B4-BE49-F238E27FC236}">
                  <a16:creationId xmlns="" xmlns:a16="http://schemas.microsoft.com/office/drawing/2014/main" id="{C4F8CBEB-2E43-9FA2-1A5C-A3339C007B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6" y="2464"/>
              <a:ext cx="10" cy="3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="" xmlns:a16="http://schemas.microsoft.com/office/drawing/2014/main" id="{0007F02A-E102-02D8-6E71-57B9E9334E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1" y="2531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8">
              <a:extLst>
                <a:ext uri="{FF2B5EF4-FFF2-40B4-BE49-F238E27FC236}">
                  <a16:creationId xmlns="" xmlns:a16="http://schemas.microsoft.com/office/drawing/2014/main" id="{BD94D27A-08C5-0CC9-B1E4-2189EF0C3E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3" y="2500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9">
              <a:extLst>
                <a:ext uri="{FF2B5EF4-FFF2-40B4-BE49-F238E27FC236}">
                  <a16:creationId xmlns="" xmlns:a16="http://schemas.microsoft.com/office/drawing/2014/main" id="{85958D96-1951-D548-EB8C-2F7D198CA9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9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="" xmlns:a16="http://schemas.microsoft.com/office/drawing/2014/main" id="{67D20584-0394-8F86-4C20-3063F466BE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0" y="2464"/>
              <a:ext cx="6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="" xmlns:a16="http://schemas.microsoft.com/office/drawing/2014/main" id="{0DCDC06A-D587-D31C-1C75-EB6A9B589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2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="" xmlns:a16="http://schemas.microsoft.com/office/drawing/2014/main" id="{24F9D18F-0C65-903A-407A-511B8D8FDD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7" y="2464"/>
              <a:ext cx="10" cy="2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4" name="Rectangle 63">
              <a:extLst>
                <a:ext uri="{FF2B5EF4-FFF2-40B4-BE49-F238E27FC236}">
                  <a16:creationId xmlns="" xmlns:a16="http://schemas.microsoft.com/office/drawing/2014/main" id="{EE990E15-7AA1-5E1E-9C2E-CC7FAE1A22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8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5" name="Rectangle 64">
              <a:extLst>
                <a:ext uri="{FF2B5EF4-FFF2-40B4-BE49-F238E27FC236}">
                  <a16:creationId xmlns="" xmlns:a16="http://schemas.microsoft.com/office/drawing/2014/main" id="{96C8EAB6-77C0-5635-664F-56AD8D40A5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9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6" name="Rectangle 65">
              <a:extLst>
                <a:ext uri="{FF2B5EF4-FFF2-40B4-BE49-F238E27FC236}">
                  <a16:creationId xmlns="" xmlns:a16="http://schemas.microsoft.com/office/drawing/2014/main" id="{C4EFAD35-5C76-CA43-738C-3691109EFD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9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7" name="Rectangle 66">
              <a:extLst>
                <a:ext uri="{FF2B5EF4-FFF2-40B4-BE49-F238E27FC236}">
                  <a16:creationId xmlns="" xmlns:a16="http://schemas.microsoft.com/office/drawing/2014/main" id="{3332C7B8-2EC7-3DFF-F178-FBC919BCA5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5" y="2464"/>
              <a:ext cx="5" cy="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8" name="Rectangle 67">
              <a:extLst>
                <a:ext uri="{FF2B5EF4-FFF2-40B4-BE49-F238E27FC236}">
                  <a16:creationId xmlns="" xmlns:a16="http://schemas.microsoft.com/office/drawing/2014/main" id="{ADDB7F90-B109-003A-78C3-4907075AF9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5" y="2464"/>
              <a:ext cx="10" cy="3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9" name="Rectangle 68">
              <a:extLst>
                <a:ext uri="{FF2B5EF4-FFF2-40B4-BE49-F238E27FC236}">
                  <a16:creationId xmlns="" xmlns:a16="http://schemas.microsoft.com/office/drawing/2014/main" id="{E2DEB06A-7B95-9373-9019-4AD877025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8" y="2531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0" name="Rectangle 69">
              <a:extLst>
                <a:ext uri="{FF2B5EF4-FFF2-40B4-BE49-F238E27FC236}">
                  <a16:creationId xmlns="" xmlns:a16="http://schemas.microsoft.com/office/drawing/2014/main" id="{14774F8E-1F11-33DC-3327-4CD699309C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9" y="2500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1" name="Rectangle 70">
              <a:extLst>
                <a:ext uri="{FF2B5EF4-FFF2-40B4-BE49-F238E27FC236}">
                  <a16:creationId xmlns="" xmlns:a16="http://schemas.microsoft.com/office/drawing/2014/main" id="{C759D0CC-FD19-C3C3-58C0-597241F8FD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2" y="2669"/>
              <a:ext cx="437" cy="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nnexinV-FITC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2" name="Rectangle 71">
              <a:extLst>
                <a:ext uri="{FF2B5EF4-FFF2-40B4-BE49-F238E27FC236}">
                  <a16:creationId xmlns="" xmlns:a16="http://schemas.microsoft.com/office/drawing/2014/main" id="{974D632B-FC83-0BBD-6632-54CBF152BD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" y="2454"/>
              <a:ext cx="36" cy="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3" name="Rectangle 72">
              <a:extLst>
                <a:ext uri="{FF2B5EF4-FFF2-40B4-BE49-F238E27FC236}">
                  <a16:creationId xmlns="" xmlns:a16="http://schemas.microsoft.com/office/drawing/2014/main" id="{211C505D-F267-0CDB-F120-1664CCA519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6" y="2413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4" name="Rectangle 73">
              <a:extLst>
                <a:ext uri="{FF2B5EF4-FFF2-40B4-BE49-F238E27FC236}">
                  <a16:creationId xmlns="" xmlns:a16="http://schemas.microsoft.com/office/drawing/2014/main" id="{3D49BE9D-FDAA-8831-F1AD-0440111203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8" y="2382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5" name="Rectangle 74">
              <a:extLst>
                <a:ext uri="{FF2B5EF4-FFF2-40B4-BE49-F238E27FC236}">
                  <a16:creationId xmlns="" xmlns:a16="http://schemas.microsoft.com/office/drawing/2014/main" id="{F9005717-BAD2-F876-5E25-9375D6FF73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361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6" name="Rectangle 75">
              <a:extLst>
                <a:ext uri="{FF2B5EF4-FFF2-40B4-BE49-F238E27FC236}">
                  <a16:creationId xmlns="" xmlns:a16="http://schemas.microsoft.com/office/drawing/2014/main" id="{75615686-74AF-5DFB-1357-7F604F15A6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305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7" name="Rectangle 76">
              <a:extLst>
                <a:ext uri="{FF2B5EF4-FFF2-40B4-BE49-F238E27FC236}">
                  <a16:creationId xmlns="" xmlns:a16="http://schemas.microsoft.com/office/drawing/2014/main" id="{40218F0F-780D-8383-A5F5-46A18FED18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264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8" name="Rectangle 77">
              <a:extLst>
                <a:ext uri="{FF2B5EF4-FFF2-40B4-BE49-F238E27FC236}">
                  <a16:creationId xmlns="" xmlns:a16="http://schemas.microsoft.com/office/drawing/2014/main" id="{7EF6ACBD-178F-9784-E365-64785AB62B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4" y="2223"/>
              <a:ext cx="26" cy="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9" name="Rectangle 78">
              <a:extLst>
                <a:ext uri="{FF2B5EF4-FFF2-40B4-BE49-F238E27FC236}">
                  <a16:creationId xmlns="" xmlns:a16="http://schemas.microsoft.com/office/drawing/2014/main" id="{45C962C1-1C03-31E6-696A-52C432D798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202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0" name="Rectangle 79">
              <a:extLst>
                <a:ext uri="{FF2B5EF4-FFF2-40B4-BE49-F238E27FC236}">
                  <a16:creationId xmlns="" xmlns:a16="http://schemas.microsoft.com/office/drawing/2014/main" id="{3136D41C-EA5F-9721-BDCA-4535BC9532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181"/>
              <a:ext cx="16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1" name="Rectangle 80">
              <a:extLst>
                <a:ext uri="{FF2B5EF4-FFF2-40B4-BE49-F238E27FC236}">
                  <a16:creationId xmlns="" xmlns:a16="http://schemas.microsoft.com/office/drawing/2014/main" id="{7963AD3A-CCFA-6733-5B67-81ADB7B8CB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161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2" name="Rectangle 81">
              <a:extLst>
                <a:ext uri="{FF2B5EF4-FFF2-40B4-BE49-F238E27FC236}">
                  <a16:creationId xmlns="" xmlns:a16="http://schemas.microsoft.com/office/drawing/2014/main" id="{EA62EE47-7AF8-5159-9E5E-74AF9A7766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145"/>
              <a:ext cx="16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3" name="Rectangle 82">
              <a:extLst>
                <a:ext uri="{FF2B5EF4-FFF2-40B4-BE49-F238E27FC236}">
                  <a16:creationId xmlns="" xmlns:a16="http://schemas.microsoft.com/office/drawing/2014/main" id="{E2F04C6C-4537-F24C-1EE2-15A0FD08F3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" y="2125"/>
              <a:ext cx="36" cy="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6" name="Rectangle 83">
              <a:extLst>
                <a:ext uri="{FF2B5EF4-FFF2-40B4-BE49-F238E27FC236}">
                  <a16:creationId xmlns="" xmlns:a16="http://schemas.microsoft.com/office/drawing/2014/main" id="{C71B25DD-1008-2402-0F46-175D25C98E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6" y="2115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7" name="Rectangle 84">
              <a:extLst>
                <a:ext uri="{FF2B5EF4-FFF2-40B4-BE49-F238E27FC236}">
                  <a16:creationId xmlns="" xmlns:a16="http://schemas.microsoft.com/office/drawing/2014/main" id="{1A4B9C0E-400D-F6D0-3A9E-A3557567C4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8" y="2084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8" name="Rectangle 85">
              <a:extLst>
                <a:ext uri="{FF2B5EF4-FFF2-40B4-BE49-F238E27FC236}">
                  <a16:creationId xmlns="" xmlns:a16="http://schemas.microsoft.com/office/drawing/2014/main" id="{92D61482-E32C-7824-9005-039124C71B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032"/>
              <a:ext cx="16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9" name="Rectangle 86">
              <a:extLst>
                <a:ext uri="{FF2B5EF4-FFF2-40B4-BE49-F238E27FC236}">
                  <a16:creationId xmlns="" xmlns:a16="http://schemas.microsoft.com/office/drawing/2014/main" id="{10098E62-C68D-C697-0E26-4FB6E8EA86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976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0" name="Rectangle 87">
              <a:extLst>
                <a:ext uri="{FF2B5EF4-FFF2-40B4-BE49-F238E27FC236}">
                  <a16:creationId xmlns="" xmlns:a16="http://schemas.microsoft.com/office/drawing/2014/main" id="{87907C2E-C10B-D711-1691-D2CB3B3912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935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1" name="Rectangle 88">
              <a:extLst>
                <a:ext uri="{FF2B5EF4-FFF2-40B4-BE49-F238E27FC236}">
                  <a16:creationId xmlns="" xmlns:a16="http://schemas.microsoft.com/office/drawing/2014/main" id="{69887A22-3E00-D426-3645-AA20034A46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4" y="1899"/>
              <a:ext cx="26" cy="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2" name="Rectangle 89">
              <a:extLst>
                <a:ext uri="{FF2B5EF4-FFF2-40B4-BE49-F238E27FC236}">
                  <a16:creationId xmlns="" xmlns:a16="http://schemas.microsoft.com/office/drawing/2014/main" id="{25DF158B-1FFC-E8F7-CE3C-367E0FE948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878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3" name="Rectangle 90">
              <a:extLst>
                <a:ext uri="{FF2B5EF4-FFF2-40B4-BE49-F238E27FC236}">
                  <a16:creationId xmlns="" xmlns:a16="http://schemas.microsoft.com/office/drawing/2014/main" id="{511A735C-69B3-40A8-4668-97236929A6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853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4" name="Rectangle 91">
              <a:extLst>
                <a:ext uri="{FF2B5EF4-FFF2-40B4-BE49-F238E27FC236}">
                  <a16:creationId xmlns="" xmlns:a16="http://schemas.microsoft.com/office/drawing/2014/main" id="{D4420D82-B276-2D6E-6AB4-B35E06D9A9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837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5" name="Rectangle 92">
              <a:extLst>
                <a:ext uri="{FF2B5EF4-FFF2-40B4-BE49-F238E27FC236}">
                  <a16:creationId xmlns="" xmlns:a16="http://schemas.microsoft.com/office/drawing/2014/main" id="{F2A5607B-3396-5F6D-9EF8-01F93B4F90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817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6" name="Rectangle 93">
              <a:extLst>
                <a:ext uri="{FF2B5EF4-FFF2-40B4-BE49-F238E27FC236}">
                  <a16:creationId xmlns="" xmlns:a16="http://schemas.microsoft.com/office/drawing/2014/main" id="{AD7B5148-9910-F722-FB78-7A3B0BF511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" y="1796"/>
              <a:ext cx="36" cy="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7" name="Rectangle 94">
              <a:extLst>
                <a:ext uri="{FF2B5EF4-FFF2-40B4-BE49-F238E27FC236}">
                  <a16:creationId xmlns="" xmlns:a16="http://schemas.microsoft.com/office/drawing/2014/main" id="{C64C07FD-3221-DBC6-C9C5-F07DE82561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6" y="1786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8" name="Rectangle 95">
              <a:extLst>
                <a:ext uri="{FF2B5EF4-FFF2-40B4-BE49-F238E27FC236}">
                  <a16:creationId xmlns="" xmlns:a16="http://schemas.microsoft.com/office/drawing/2014/main" id="{A5D87DCD-18A0-5976-968A-C290A22801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8" y="1755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9" name="Rectangle 96">
              <a:extLst>
                <a:ext uri="{FF2B5EF4-FFF2-40B4-BE49-F238E27FC236}">
                  <a16:creationId xmlns="" xmlns:a16="http://schemas.microsoft.com/office/drawing/2014/main" id="{E2F72E86-C661-2537-365D-DAF51C21DD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703"/>
              <a:ext cx="16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0" name="Rectangle 97">
              <a:extLst>
                <a:ext uri="{FF2B5EF4-FFF2-40B4-BE49-F238E27FC236}">
                  <a16:creationId xmlns="" xmlns:a16="http://schemas.microsoft.com/office/drawing/2014/main" id="{44EC9483-FC4D-77A4-328C-45F405B97A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647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1" name="Rectangle 98">
              <a:extLst>
                <a:ext uri="{FF2B5EF4-FFF2-40B4-BE49-F238E27FC236}">
                  <a16:creationId xmlns="" xmlns:a16="http://schemas.microsoft.com/office/drawing/2014/main" id="{82C493E1-4448-71C1-032E-6A9D58FCB6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606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2" name="Rectangle 99">
              <a:extLst>
                <a:ext uri="{FF2B5EF4-FFF2-40B4-BE49-F238E27FC236}">
                  <a16:creationId xmlns="" xmlns:a16="http://schemas.microsoft.com/office/drawing/2014/main" id="{932F2733-051C-8C3B-564C-D2AF86F79D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4" y="1570"/>
              <a:ext cx="26" cy="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3" name="Rectangle 100">
              <a:extLst>
                <a:ext uri="{FF2B5EF4-FFF2-40B4-BE49-F238E27FC236}">
                  <a16:creationId xmlns="" xmlns:a16="http://schemas.microsoft.com/office/drawing/2014/main" id="{73011E6F-0DF0-39EA-AD38-C70F54F64A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549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4" name="Rectangle 101">
              <a:extLst>
                <a:ext uri="{FF2B5EF4-FFF2-40B4-BE49-F238E27FC236}">
                  <a16:creationId xmlns="" xmlns:a16="http://schemas.microsoft.com/office/drawing/2014/main" id="{D1199279-5FFC-B67F-C7F9-73A0010976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529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5" name="Rectangle 102">
              <a:extLst>
                <a:ext uri="{FF2B5EF4-FFF2-40B4-BE49-F238E27FC236}">
                  <a16:creationId xmlns="" xmlns:a16="http://schemas.microsoft.com/office/drawing/2014/main" id="{48D52003-ADDA-1EAF-2822-1AE257A62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508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6" name="Rectangle 103">
              <a:extLst>
                <a:ext uri="{FF2B5EF4-FFF2-40B4-BE49-F238E27FC236}">
                  <a16:creationId xmlns="" xmlns:a16="http://schemas.microsoft.com/office/drawing/2014/main" id="{F26BD476-C668-A30E-F54C-D7A673EE06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493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7" name="Rectangle 104">
              <a:extLst>
                <a:ext uri="{FF2B5EF4-FFF2-40B4-BE49-F238E27FC236}">
                  <a16:creationId xmlns="" xmlns:a16="http://schemas.microsoft.com/office/drawing/2014/main" id="{E39C44C0-58A0-37AE-59AD-7A1E0FC6B7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" y="1472"/>
              <a:ext cx="36" cy="1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8" name="Rectangle 105">
              <a:extLst>
                <a:ext uri="{FF2B5EF4-FFF2-40B4-BE49-F238E27FC236}">
                  <a16:creationId xmlns="" xmlns:a16="http://schemas.microsoft.com/office/drawing/2014/main" id="{40BE2720-D169-6867-BEF8-ADB0EF1B7B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6" y="1462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9" name="Rectangle 106">
              <a:extLst>
                <a:ext uri="{FF2B5EF4-FFF2-40B4-BE49-F238E27FC236}">
                  <a16:creationId xmlns="" xmlns:a16="http://schemas.microsoft.com/office/drawing/2014/main" id="{E4486BE4-C7C6-3E6D-3F01-EAC6C4DE2A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8" y="1431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0" name="Rectangle 107">
              <a:extLst>
                <a:ext uri="{FF2B5EF4-FFF2-40B4-BE49-F238E27FC236}">
                  <a16:creationId xmlns="" xmlns:a16="http://schemas.microsoft.com/office/drawing/2014/main" id="{7724E2DC-1FF7-4177-3E28-AE6D715514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380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1" name="Rectangle 108">
              <a:extLst>
                <a:ext uri="{FF2B5EF4-FFF2-40B4-BE49-F238E27FC236}">
                  <a16:creationId xmlns="" xmlns:a16="http://schemas.microsoft.com/office/drawing/2014/main" id="{8FAF066E-698C-6540-2D02-D4AEF5BB0C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318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2" name="Rectangle 109">
              <a:extLst>
                <a:ext uri="{FF2B5EF4-FFF2-40B4-BE49-F238E27FC236}">
                  <a16:creationId xmlns="" xmlns:a16="http://schemas.microsoft.com/office/drawing/2014/main" id="{3520EC7C-3D6F-B554-336A-773D7AC4B6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277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3" name="Rectangle 110">
              <a:extLst>
                <a:ext uri="{FF2B5EF4-FFF2-40B4-BE49-F238E27FC236}">
                  <a16:creationId xmlns="" xmlns:a16="http://schemas.microsoft.com/office/drawing/2014/main" id="{32A3D0D5-31AF-A5EC-EC48-4D4DAA1AB1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4" y="1241"/>
              <a:ext cx="26" cy="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4" name="Rectangle 111">
              <a:extLst>
                <a:ext uri="{FF2B5EF4-FFF2-40B4-BE49-F238E27FC236}">
                  <a16:creationId xmlns="" xmlns:a16="http://schemas.microsoft.com/office/drawing/2014/main" id="{DA6E2A0D-D14E-6488-3DD0-7219D340DF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220"/>
              <a:ext cx="16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5" name="Rectangle 112">
              <a:extLst>
                <a:ext uri="{FF2B5EF4-FFF2-40B4-BE49-F238E27FC236}">
                  <a16:creationId xmlns="" xmlns:a16="http://schemas.microsoft.com/office/drawing/2014/main" id="{16C6F5D8-FCC2-F934-1873-D9B1864F68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200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6" name="Rectangle 113">
              <a:extLst>
                <a:ext uri="{FF2B5EF4-FFF2-40B4-BE49-F238E27FC236}">
                  <a16:creationId xmlns="" xmlns:a16="http://schemas.microsoft.com/office/drawing/2014/main" id="{9C09B797-038A-2312-CE98-E61F064F59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179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7" name="Rectangle 114">
              <a:extLst>
                <a:ext uri="{FF2B5EF4-FFF2-40B4-BE49-F238E27FC236}">
                  <a16:creationId xmlns="" xmlns:a16="http://schemas.microsoft.com/office/drawing/2014/main" id="{F71F10C1-795F-83D5-9F30-DDD7264777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1164"/>
              <a:ext cx="16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8" name="Rectangle 115">
              <a:extLst>
                <a:ext uri="{FF2B5EF4-FFF2-40B4-BE49-F238E27FC236}">
                  <a16:creationId xmlns="" xmlns:a16="http://schemas.microsoft.com/office/drawing/2014/main" id="{1CE7B878-60E2-C841-2C17-D4D0F43FA6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" y="1148"/>
              <a:ext cx="36" cy="1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9" name="Rectangle 116">
              <a:extLst>
                <a:ext uri="{FF2B5EF4-FFF2-40B4-BE49-F238E27FC236}">
                  <a16:creationId xmlns="" xmlns:a16="http://schemas.microsoft.com/office/drawing/2014/main" id="{26ADA986-80D3-69FB-1D5F-813EC2C969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6" y="1180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0" name="Rectangle 117">
              <a:extLst>
                <a:ext uri="{FF2B5EF4-FFF2-40B4-BE49-F238E27FC236}">
                  <a16:creationId xmlns="" xmlns:a16="http://schemas.microsoft.com/office/drawing/2014/main" id="{9D37EA96-1A52-E42C-63F7-3ADF31A15F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8" y="1149"/>
              <a:ext cx="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1" name="Rectangle 118">
              <a:extLst>
                <a:ext uri="{FF2B5EF4-FFF2-40B4-BE49-F238E27FC236}">
                  <a16:creationId xmlns="" xmlns:a16="http://schemas.microsoft.com/office/drawing/2014/main" id="{F3916E2F-90EB-CB2D-C5F5-942007F2A34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442" y="1699"/>
              <a:ext cx="509" cy="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opidium Iodid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9" name="TextBox 23">
            <a:extLst>
              <a:ext uri="{FF2B5EF4-FFF2-40B4-BE49-F238E27FC236}">
                <a16:creationId xmlns="" xmlns:a16="http://schemas.microsoft.com/office/drawing/2014/main" id="{10833D8F-D6AE-5D6C-44D6-D37FD6D8EA4F}"/>
              </a:ext>
            </a:extLst>
          </p:cNvPr>
          <p:cNvSpPr txBox="1"/>
          <p:nvPr/>
        </p:nvSpPr>
        <p:spPr>
          <a:xfrm>
            <a:off x="68659" y="399104"/>
            <a:ext cx="331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2" name="TextBox 23">
            <a:extLst>
              <a:ext uri="{FF2B5EF4-FFF2-40B4-BE49-F238E27FC236}">
                <a16:creationId xmlns="" xmlns:a16="http://schemas.microsoft.com/office/drawing/2014/main" id="{ADD843E2-A89A-72C6-F7C5-BE265FE9C820}"/>
              </a:ext>
            </a:extLst>
          </p:cNvPr>
          <p:cNvSpPr txBox="1"/>
          <p:nvPr/>
        </p:nvSpPr>
        <p:spPr>
          <a:xfrm>
            <a:off x="3689089" y="399376"/>
            <a:ext cx="331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3" name="TextBox 23">
            <a:extLst>
              <a:ext uri="{FF2B5EF4-FFF2-40B4-BE49-F238E27FC236}">
                <a16:creationId xmlns="" xmlns:a16="http://schemas.microsoft.com/office/drawing/2014/main" id="{4191BDD0-1383-8AAF-6CF4-F346F2F914EB}"/>
              </a:ext>
            </a:extLst>
          </p:cNvPr>
          <p:cNvSpPr txBox="1"/>
          <p:nvPr/>
        </p:nvSpPr>
        <p:spPr>
          <a:xfrm>
            <a:off x="7345512" y="406004"/>
            <a:ext cx="331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4" name="TextBox 23">
            <a:extLst>
              <a:ext uri="{FF2B5EF4-FFF2-40B4-BE49-F238E27FC236}">
                <a16:creationId xmlns="" xmlns:a16="http://schemas.microsoft.com/office/drawing/2014/main" id="{F59FAACB-E11D-4E34-9F93-945D61D7ABE2}"/>
              </a:ext>
            </a:extLst>
          </p:cNvPr>
          <p:cNvSpPr txBox="1"/>
          <p:nvPr/>
        </p:nvSpPr>
        <p:spPr>
          <a:xfrm>
            <a:off x="70576" y="3153903"/>
            <a:ext cx="331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5" name="TextBox 1">
            <a:extLst>
              <a:ext uri="{FF2B5EF4-FFF2-40B4-BE49-F238E27FC236}">
                <a16:creationId xmlns="" xmlns:a16="http://schemas.microsoft.com/office/drawing/2014/main" id="{02A1E2CE-130B-61D0-4223-ED08622CD86C}"/>
              </a:ext>
            </a:extLst>
          </p:cNvPr>
          <p:cNvSpPr txBox="1"/>
          <p:nvPr/>
        </p:nvSpPr>
        <p:spPr>
          <a:xfrm>
            <a:off x="0" y="43200"/>
            <a:ext cx="7452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ffect of CSO on apoptosis of FLS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7" name="文本框 1086">
            <a:extLst>
              <a:ext uri="{FF2B5EF4-FFF2-40B4-BE49-F238E27FC236}">
                <a16:creationId xmlns="" xmlns:a16="http://schemas.microsoft.com/office/drawing/2014/main" id="{795403A4-5549-2B5A-D70C-BC6F9CEDCB29}"/>
              </a:ext>
            </a:extLst>
          </p:cNvPr>
          <p:cNvSpPr txBox="1"/>
          <p:nvPr/>
        </p:nvSpPr>
        <p:spPr>
          <a:xfrm>
            <a:off x="-49153" y="6040980"/>
            <a:ext cx="12307828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 file 2 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CSO on apoptosis of FLS. 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FACS scatterplot of the Negative Control (NC) group. 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FACS scatterplot of the CSO </a:t>
            </a:r>
            <a:r>
              <a:rPr lang="el-GR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00 μ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 group. 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FACS scatterplot of the TNF-α (10 ng/ml) group. 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FACS scatterplot of the TNF-α (10 ng/ml) + CSO </a:t>
            </a:r>
            <a:r>
              <a:rPr lang="el-GR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00 μ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 group. 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 of apoptosis cells (%). </a:t>
            </a:r>
            <a:r>
              <a:rPr lang="en-US" altLang="zh-CN" sz="15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Datasets are shown as the mean ± SD. *</a:t>
            </a:r>
            <a:r>
              <a:rPr lang="en-US" altLang="zh-CN" sz="15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en-US" altLang="zh-CN" sz="15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&lt;0.05, **</a:t>
            </a:r>
            <a:r>
              <a:rPr lang="en-US" altLang="zh-CN" sz="15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en-US" altLang="zh-CN" sz="15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&lt;0.01 </a:t>
            </a:r>
            <a:r>
              <a:rPr lang="en-US" altLang="zh-CN" sz="15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vs.</a:t>
            </a:r>
            <a:r>
              <a:rPr lang="en-US" altLang="zh-CN" sz="15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NC 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. n=3.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2" name="TextBox 23">
            <a:extLst>
              <a:ext uri="{FF2B5EF4-FFF2-40B4-BE49-F238E27FC236}">
                <a16:creationId xmlns="" xmlns:a16="http://schemas.microsoft.com/office/drawing/2014/main" id="{8C14E598-B1F9-C0A9-1DB2-E9143CF17D5C}"/>
              </a:ext>
            </a:extLst>
          </p:cNvPr>
          <p:cNvSpPr txBox="1"/>
          <p:nvPr/>
        </p:nvSpPr>
        <p:spPr>
          <a:xfrm>
            <a:off x="3707967" y="3156562"/>
            <a:ext cx="331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E     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8" name="TextBox 23">
            <a:extLst>
              <a:ext uri="{FF2B5EF4-FFF2-40B4-BE49-F238E27FC236}">
                <a16:creationId xmlns="" xmlns:a16="http://schemas.microsoft.com/office/drawing/2014/main" id="{B247FA3D-3789-0B6A-20BC-0743F883DADE}"/>
              </a:ext>
            </a:extLst>
          </p:cNvPr>
          <p:cNvSpPr txBox="1"/>
          <p:nvPr/>
        </p:nvSpPr>
        <p:spPr>
          <a:xfrm>
            <a:off x="1400663" y="442782"/>
            <a:ext cx="485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3" name="文本框 1092">
            <a:extLst>
              <a:ext uri="{FF2B5EF4-FFF2-40B4-BE49-F238E27FC236}">
                <a16:creationId xmlns="" xmlns:a16="http://schemas.microsoft.com/office/drawing/2014/main" id="{9A2C5CB8-EDB7-FACC-CC1E-9DB83926A33A}"/>
              </a:ext>
            </a:extLst>
          </p:cNvPr>
          <p:cNvSpPr txBox="1"/>
          <p:nvPr/>
        </p:nvSpPr>
        <p:spPr>
          <a:xfrm>
            <a:off x="4560408" y="396640"/>
            <a:ext cx="186270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SO(500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4" name="文本框 1093">
            <a:extLst>
              <a:ext uri="{FF2B5EF4-FFF2-40B4-BE49-F238E27FC236}">
                <a16:creationId xmlns="" xmlns:a16="http://schemas.microsoft.com/office/drawing/2014/main" id="{C289195C-B66C-40A1-4A5F-691F5E05C58C}"/>
              </a:ext>
            </a:extLst>
          </p:cNvPr>
          <p:cNvSpPr txBox="1"/>
          <p:nvPr/>
        </p:nvSpPr>
        <p:spPr>
          <a:xfrm>
            <a:off x="384185" y="3258587"/>
            <a:ext cx="27749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NF-α(10ng/ml)+CSO(500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5" name="文本框 1094">
            <a:extLst>
              <a:ext uri="{FF2B5EF4-FFF2-40B4-BE49-F238E27FC236}">
                <a16:creationId xmlns="" xmlns:a16="http://schemas.microsoft.com/office/drawing/2014/main" id="{F9ED9A0A-7738-9CFF-E7FE-9BB929A4FC91}"/>
              </a:ext>
            </a:extLst>
          </p:cNvPr>
          <p:cNvSpPr txBox="1"/>
          <p:nvPr/>
        </p:nvSpPr>
        <p:spPr>
          <a:xfrm>
            <a:off x="8450253" y="413261"/>
            <a:ext cx="144622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NF-α(10 ng/ml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89" name="图片 1088">
            <a:extLst>
              <a:ext uri="{FF2B5EF4-FFF2-40B4-BE49-F238E27FC236}">
                <a16:creationId xmlns="" xmlns:a16="http://schemas.microsoft.com/office/drawing/2014/main" id="{32C85906-7D9C-DB61-F2DB-AFC67FBFB6C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5365" y="3279135"/>
            <a:ext cx="2952055" cy="2927591"/>
          </a:xfrm>
          <a:prstGeom prst="rect">
            <a:avLst/>
          </a:prstGeom>
        </p:spPr>
      </p:pic>
      <p:pic>
        <p:nvPicPr>
          <p:cNvPr id="1100" name="图片 1099">
            <a:extLst>
              <a:ext uri="{FF2B5EF4-FFF2-40B4-BE49-F238E27FC236}">
                <a16:creationId xmlns="" xmlns:a16="http://schemas.microsoft.com/office/drawing/2014/main" id="{148BD265-8D01-4B88-5DBA-98464E98DD15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3348" y="3411429"/>
            <a:ext cx="2798064" cy="2392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9275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</TotalTime>
  <Words>154</Words>
  <Application>Microsoft Office PowerPoint</Application>
  <PresentationFormat>Widescreen</PresentationFormat>
  <Paragraphs>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等线</vt:lpstr>
      <vt:lpstr>等线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强 强</dc:creator>
  <cp:lastModifiedBy>Chandravadhana Ramesh</cp:lastModifiedBy>
  <cp:revision>9</cp:revision>
  <dcterms:created xsi:type="dcterms:W3CDTF">2023-08-01T13:23:05Z</dcterms:created>
  <dcterms:modified xsi:type="dcterms:W3CDTF">2023-09-07T07:22:37Z</dcterms:modified>
</cp:coreProperties>
</file>